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anzQC-JF" initials="JF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60" y="8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CE91D1-E404-4EAB-9FB6-C6531D0D406C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936C8-C058-4491-BDDA-56099C80B6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67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8936C8-C058-4491-BDDA-56099C80B65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8142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5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00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6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43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886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34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42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64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205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582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5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41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1547"/>
            <a:ext cx="23038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353718" y="3419872"/>
            <a:ext cx="6118665" cy="5398538"/>
            <a:chOff x="353718" y="899592"/>
            <a:chExt cx="6118665" cy="5398538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1120332" y="5364861"/>
              <a:ext cx="5352051" cy="933269"/>
              <a:chOff x="1120332" y="5364861"/>
              <a:chExt cx="5352051" cy="933269"/>
            </a:xfrm>
          </p:grpSpPr>
          <p:sp>
            <p:nvSpPr>
              <p:cNvPr id="20" name="テキスト ボックス 19"/>
              <p:cNvSpPr txBox="1"/>
              <p:nvPr/>
            </p:nvSpPr>
            <p:spPr>
              <a:xfrm rot="18650090">
                <a:off x="974138" y="5692996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277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 rot="18650090">
                <a:off x="1164950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274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 rot="18650090">
                <a:off x="1596998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319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 rot="18650090">
                <a:off x="2090194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45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 rot="18650090">
                <a:off x="2533102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97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 rot="18650090">
                <a:off x="2965150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174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 rot="18650090">
                <a:off x="3783904" y="5692996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277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 rot="18650090">
                <a:off x="3974716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274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 rot="18650090">
                <a:off x="4406764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319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 rot="18650090">
                <a:off x="4899960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45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 rot="18650090">
                <a:off x="5342868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097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 rot="18650090">
                <a:off x="5774916" y="5600663"/>
                <a:ext cx="93326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N_1740 </a:t>
                </a:r>
              </a:p>
              <a:p>
                <a:pPr algn="ctr"/>
                <a:r>
                  <a:rPr lang="en-US" altLang="ja-JP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nt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" name="直線コネクタ 4"/>
            <p:cNvCxnSpPr/>
            <p:nvPr/>
          </p:nvCxnSpPr>
          <p:spPr>
            <a:xfrm>
              <a:off x="1240249" y="1259632"/>
              <a:ext cx="228035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/>
            <p:cNvCxnSpPr/>
            <p:nvPr/>
          </p:nvCxnSpPr>
          <p:spPr>
            <a:xfrm>
              <a:off x="3977124" y="1259632"/>
              <a:ext cx="228035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/>
            <p:cNvSpPr txBox="1"/>
            <p:nvPr/>
          </p:nvSpPr>
          <p:spPr>
            <a:xfrm>
              <a:off x="1257418" y="899592"/>
              <a:ext cx="23807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LCK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1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upeptin</a:t>
              </a:r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921714" y="899592"/>
              <a:ext cx="22846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LCK</a:t>
              </a:r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1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upeptin</a:t>
              </a:r>
              <a:r>
                <a:rPr kumimoji="1"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-)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53718" y="1090355"/>
              <a:ext cx="5485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409823" y="1536044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09823" y="1907056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409823" y="2238196"/>
              <a:ext cx="4924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512416" y="248753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12416" y="2905183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512416" y="3248560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12416" y="3752616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512416" y="4017422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12416" y="452147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557" r="1010"/>
            <a:stretch/>
          </p:blipFill>
          <p:spPr bwMode="auto">
            <a:xfrm>
              <a:off x="980728" y="1501618"/>
              <a:ext cx="5340468" cy="3719155"/>
            </a:xfrm>
            <a:prstGeom prst="rect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sp>
        <p:nvSpPr>
          <p:cNvPr id="32" name="テキスト ボックス 31"/>
          <p:cNvSpPr txBox="1"/>
          <p:nvPr/>
        </p:nvSpPr>
        <p:spPr>
          <a:xfrm>
            <a:off x="162659" y="827584"/>
            <a:ext cx="653268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 -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profile on an SDS-PAGE gel. 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n micrograms of the whole cell protein 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wild-type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ngivalis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 33277 and ECF sigma factor mutants were separated by SDS-PAGE and stained with CBB. Left side: with TLCK,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peptin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 side: without TLCK,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peptin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78315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5</TotalTime>
  <Words>99</Words>
  <Application>Microsoft Office PowerPoint</Application>
  <PresentationFormat>画面に合わせる (4:3)</PresentationFormat>
  <Paragraphs>3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池有一郎</dc:creator>
  <cp:lastModifiedBy>菊池有一郎</cp:lastModifiedBy>
  <cp:revision>49</cp:revision>
  <cp:lastPrinted>2014-11-25T09:31:52Z</cp:lastPrinted>
  <dcterms:created xsi:type="dcterms:W3CDTF">2014-12-22T02:55:55Z</dcterms:created>
  <dcterms:modified xsi:type="dcterms:W3CDTF">2015-01-05T01:50:20Z</dcterms:modified>
</cp:coreProperties>
</file>